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9144000" cy="6858000" type="screen4x3"/>
  <p:notesSz cx="6946900" cy="9220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370" autoAdjust="0"/>
  </p:normalViewPr>
  <p:slideViewPr>
    <p:cSldViewPr>
      <p:cViewPr varScale="1">
        <p:scale>
          <a:sx n="91" d="100"/>
          <a:sy n="91" d="100"/>
        </p:scale>
        <p:origin x="102" y="2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0323" cy="461010"/>
          </a:xfrm>
          <a:prstGeom prst="rect">
            <a:avLst/>
          </a:prstGeom>
        </p:spPr>
        <p:txBody>
          <a:bodyPr vert="horz" lIns="92382" tIns="46191" rIns="92382" bIns="4619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4969" y="0"/>
            <a:ext cx="3010323" cy="461010"/>
          </a:xfrm>
          <a:prstGeom prst="rect">
            <a:avLst/>
          </a:prstGeom>
        </p:spPr>
        <p:txBody>
          <a:bodyPr vert="horz" lIns="92382" tIns="46191" rIns="92382" bIns="46191" rtlCol="0"/>
          <a:lstStyle>
            <a:lvl1pPr algn="r">
              <a:defRPr sz="1200"/>
            </a:lvl1pPr>
          </a:lstStyle>
          <a:p>
            <a:fld id="{91BC6075-9586-4E17-9C11-937AFD80C67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8400" y="692150"/>
            <a:ext cx="4610100" cy="3457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382" tIns="46191" rIns="92382" bIns="4619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4690" y="4379595"/>
            <a:ext cx="5557520" cy="4149090"/>
          </a:xfrm>
          <a:prstGeom prst="rect">
            <a:avLst/>
          </a:prstGeom>
        </p:spPr>
        <p:txBody>
          <a:bodyPr vert="horz" lIns="92382" tIns="46191" rIns="92382" bIns="4619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57590"/>
            <a:ext cx="3010323" cy="461010"/>
          </a:xfrm>
          <a:prstGeom prst="rect">
            <a:avLst/>
          </a:prstGeom>
        </p:spPr>
        <p:txBody>
          <a:bodyPr vert="horz" lIns="92382" tIns="46191" rIns="92382" bIns="4619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4969" y="8757590"/>
            <a:ext cx="3010323" cy="461010"/>
          </a:xfrm>
          <a:prstGeom prst="rect">
            <a:avLst/>
          </a:prstGeom>
        </p:spPr>
        <p:txBody>
          <a:bodyPr vert="horz" lIns="92382" tIns="46191" rIns="92382" bIns="46191" rtlCol="0" anchor="b"/>
          <a:lstStyle>
            <a:lvl1pPr algn="r">
              <a:defRPr sz="1200"/>
            </a:lvl1pPr>
          </a:lstStyle>
          <a:p>
            <a:fld id="{2124B545-F54C-47C1-BE02-D1A9AA0FA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9326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5545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613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970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8700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125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628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083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239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90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147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661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C1F40-B817-4B2B-B314-4E2EB64EFEFE}" type="datetimeFigureOut">
              <a:rPr lang="en-US" smtClean="0"/>
              <a:t>6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022800-35A8-45BB-894F-9ACF37E1F1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318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0.png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image" Target="../media/image9.png"/><Relationship Id="rId2" Type="http://schemas.openxmlformats.org/officeDocument/2006/relationships/slideLayout" Target="../slideLayouts/slideLayout6.xml"/><Relationship Id="rId16" Type="http://schemas.openxmlformats.org/officeDocument/2006/relationships/image" Target="../media/image8.png"/><Relationship Id="rId20" Type="http://schemas.openxmlformats.org/officeDocument/2006/relationships/image" Target="../media/image12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7.png"/><Relationship Id="rId10" Type="http://schemas.openxmlformats.org/officeDocument/2006/relationships/image" Target="../media/image4.emf"/><Relationship Id="rId19" Type="http://schemas.openxmlformats.org/officeDocument/2006/relationships/image" Target="../media/image11.png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A87388-317C-4670-A82D-DD5B7CDD34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6200" y="76200"/>
            <a:ext cx="2206625" cy="487362"/>
          </a:xfrm>
        </p:spPr>
        <p:txBody>
          <a:bodyPr>
            <a:normAutofit/>
          </a:bodyPr>
          <a:lstStyle/>
          <a:p>
            <a:pPr algn="l"/>
            <a:r>
              <a:rPr lang="en-US" sz="2000" b="1" dirty="0"/>
              <a:t>Suppl. Fig. 1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D53E2621-F514-4B56-8295-CB1B6AF66CBD}"/>
              </a:ext>
            </a:extLst>
          </p:cNvPr>
          <p:cNvGrpSpPr/>
          <p:nvPr/>
        </p:nvGrpSpPr>
        <p:grpSpPr>
          <a:xfrm>
            <a:off x="320417" y="514042"/>
            <a:ext cx="6232783" cy="2251383"/>
            <a:chOff x="320417" y="514042"/>
            <a:chExt cx="6232783" cy="2251383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7D89DDA1-0391-44BF-ACC1-82064294177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26770312"/>
                </p:ext>
              </p:extLst>
            </p:nvPr>
          </p:nvGraphicFramePr>
          <p:xfrm>
            <a:off x="366713" y="781050"/>
            <a:ext cx="1938337" cy="1908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67" name="Prism 7" r:id="rId3" imgW="3517085" imgH="3819434" progId="Prism7.Document">
                    <p:embed/>
                  </p:oleObj>
                </mc:Choice>
                <mc:Fallback>
                  <p:oleObj name="Prism 7" r:id="rId3" imgW="3517085" imgH="3819434" progId="Prism7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7D89DDA1-0391-44BF-ACC1-82064294177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66713" y="781050"/>
                          <a:ext cx="1938337" cy="1908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A000BA9D-D7CC-46C8-A14F-4FA7E56A418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87631023"/>
                </p:ext>
              </p:extLst>
            </p:nvPr>
          </p:nvGraphicFramePr>
          <p:xfrm>
            <a:off x="2205038" y="765108"/>
            <a:ext cx="1909762" cy="195796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68" name="Prism 7" r:id="rId5" imgW="3499079" imgH="4029764" progId="Prism7.Document">
                    <p:embed/>
                  </p:oleObj>
                </mc:Choice>
                <mc:Fallback>
                  <p:oleObj name="Prism 7" r:id="rId5" imgW="3499079" imgH="4029764" progId="Prism7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A000BA9D-D7CC-46C8-A14F-4FA7E56A418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205038" y="765108"/>
                          <a:ext cx="1909762" cy="195796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AEB5598B-7C9C-47A7-AF72-F57552F1C2C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12464533"/>
                </p:ext>
              </p:extLst>
            </p:nvPr>
          </p:nvGraphicFramePr>
          <p:xfrm>
            <a:off x="4005263" y="812800"/>
            <a:ext cx="2547937" cy="19526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69" name="Prism 7" r:id="rId7" imgW="4541671" imgH="3755326" progId="Prism7.Document">
                    <p:embed/>
                  </p:oleObj>
                </mc:Choice>
                <mc:Fallback>
                  <p:oleObj name="Prism 7" r:id="rId7" imgW="4541671" imgH="3755326" progId="Prism7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AEB5598B-7C9C-47A7-AF72-F57552F1C2C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005263" y="812800"/>
                          <a:ext cx="2547937" cy="19526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8EC17FE-4718-45E1-A46A-7A12BCB3B9B7}"/>
                </a:ext>
              </a:extLst>
            </p:cNvPr>
            <p:cNvSpPr txBox="1"/>
            <p:nvPr/>
          </p:nvSpPr>
          <p:spPr>
            <a:xfrm>
              <a:off x="1051287" y="589567"/>
              <a:ext cx="11661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MiaCaPa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8E7CCB0-3160-42C8-BFFD-FB4405D39AB5}"/>
                </a:ext>
              </a:extLst>
            </p:cNvPr>
            <p:cNvSpPr txBox="1"/>
            <p:nvPr/>
          </p:nvSpPr>
          <p:spPr>
            <a:xfrm>
              <a:off x="3037000" y="589567"/>
              <a:ext cx="849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Panc-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8054214-BD0E-4ABC-91B1-9588C412E136}"/>
                </a:ext>
              </a:extLst>
            </p:cNvPr>
            <p:cNvSpPr txBox="1"/>
            <p:nvPr/>
          </p:nvSpPr>
          <p:spPr>
            <a:xfrm>
              <a:off x="4762778" y="589567"/>
              <a:ext cx="8760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Nor-P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4A89DEF-62B6-48E7-A36B-CA590F2FC9A3}"/>
                </a:ext>
              </a:extLst>
            </p:cNvPr>
            <p:cNvSpPr txBox="1"/>
            <p:nvPr/>
          </p:nvSpPr>
          <p:spPr>
            <a:xfrm>
              <a:off x="320417" y="514042"/>
              <a:ext cx="3401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</a:t>
              </a:r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7549134B-45AF-4588-B38B-6D5AACC2C307}"/>
              </a:ext>
            </a:extLst>
          </p:cNvPr>
          <p:cNvGrpSpPr/>
          <p:nvPr/>
        </p:nvGrpSpPr>
        <p:grpSpPr>
          <a:xfrm>
            <a:off x="285246" y="4572000"/>
            <a:ext cx="6267954" cy="2097495"/>
            <a:chOff x="285246" y="4572000"/>
            <a:chExt cx="6267954" cy="2097495"/>
          </a:xfrm>
        </p:grpSpPr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2C7EA913-246F-4DB7-8917-59107DD06E2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78573924"/>
                </p:ext>
              </p:extLst>
            </p:nvPr>
          </p:nvGraphicFramePr>
          <p:xfrm>
            <a:off x="644257" y="4809112"/>
            <a:ext cx="1774258" cy="185620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70" name="Prism 7" r:id="rId9" imgW="3677346" imgH="3494575" progId="Prism7.Document">
                    <p:embed/>
                  </p:oleObj>
                </mc:Choice>
                <mc:Fallback>
                  <p:oleObj name="Prism 7" r:id="rId9" imgW="3677346" imgH="3494575" progId="Prism7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5595FB6B-4450-4C12-9829-C251453A7FB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644257" y="4809112"/>
                          <a:ext cx="1774258" cy="185620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664EED85-C9AC-4019-91C4-84B25F0275F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46950376"/>
                </p:ext>
              </p:extLst>
            </p:nvPr>
          </p:nvGraphicFramePr>
          <p:xfrm>
            <a:off x="2189915" y="4840695"/>
            <a:ext cx="1846037" cy="1828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71" name="Prism 7" r:id="rId11" imgW="3686349" imgH="3494575" progId="Prism7.Document">
                    <p:embed/>
                  </p:oleObj>
                </mc:Choice>
                <mc:Fallback>
                  <p:oleObj name="Prism 7" r:id="rId11" imgW="3686349" imgH="3494575" progId="Prism7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F878183B-DD44-48F2-ABCD-414BAF3C476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189915" y="4840695"/>
                          <a:ext cx="1846037" cy="1828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Object 13">
              <a:extLst>
                <a:ext uri="{FF2B5EF4-FFF2-40B4-BE49-F238E27FC236}">
                  <a16:creationId xmlns:a16="http://schemas.microsoft.com/office/drawing/2014/main" id="{8B5DF751-F795-4A8E-A4E8-0B580304C81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75688764"/>
                </p:ext>
              </p:extLst>
            </p:nvPr>
          </p:nvGraphicFramePr>
          <p:xfrm>
            <a:off x="3775075" y="4849875"/>
            <a:ext cx="2778125" cy="1819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72" name="Prism 7" r:id="rId13" imgW="5399875" imgH="3519065" progId="Prism7.Document">
                    <p:embed/>
                  </p:oleObj>
                </mc:Choice>
                <mc:Fallback>
                  <p:oleObj name="Prism 7" r:id="rId13" imgW="5399875" imgH="3519065" progId="Prism7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C989B3D0-0D21-43DD-928C-F432F6996F4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775075" y="4849875"/>
                          <a:ext cx="2778125" cy="1819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2A7F90E-8E07-4F29-AFA7-F1DD68FEC0C2}"/>
                </a:ext>
              </a:extLst>
            </p:cNvPr>
            <p:cNvSpPr txBox="1"/>
            <p:nvPr/>
          </p:nvSpPr>
          <p:spPr>
            <a:xfrm>
              <a:off x="1093856" y="4645163"/>
              <a:ext cx="90101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 b="1" dirty="0"/>
                <a:t>MiaCaPa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309833F-0E89-426B-BE9E-08784C3D4D73}"/>
                </a:ext>
              </a:extLst>
            </p:cNvPr>
            <p:cNvSpPr txBox="1"/>
            <p:nvPr/>
          </p:nvSpPr>
          <p:spPr>
            <a:xfrm>
              <a:off x="2795659" y="4645163"/>
              <a:ext cx="660245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50" b="1" dirty="0"/>
                <a:t>Panc-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940D4FC-2C17-4578-98F6-2B10FE6197E5}"/>
                </a:ext>
              </a:extLst>
            </p:cNvPr>
            <p:cNvSpPr txBox="1"/>
            <p:nvPr/>
          </p:nvSpPr>
          <p:spPr>
            <a:xfrm>
              <a:off x="4378663" y="4653213"/>
              <a:ext cx="797340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50" b="1" dirty="0"/>
                <a:t>Nor-P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CCE0FAA-139C-46DE-B5A3-21DC0AA62FE7}"/>
                </a:ext>
              </a:extLst>
            </p:cNvPr>
            <p:cNvSpPr txBox="1"/>
            <p:nvPr/>
          </p:nvSpPr>
          <p:spPr>
            <a:xfrm>
              <a:off x="285246" y="4572000"/>
              <a:ext cx="3289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95BB190D-412F-4993-9F33-FF3F6CCE63BF}"/>
              </a:ext>
            </a:extLst>
          </p:cNvPr>
          <p:cNvGrpSpPr/>
          <p:nvPr/>
        </p:nvGrpSpPr>
        <p:grpSpPr>
          <a:xfrm>
            <a:off x="228600" y="2801670"/>
            <a:ext cx="5378440" cy="1465530"/>
            <a:chOff x="228600" y="2801670"/>
            <a:chExt cx="5378440" cy="1465530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62A26BF-42FD-42CF-A6EA-5D17AD44CF25}"/>
                </a:ext>
              </a:extLst>
            </p:cNvPr>
            <p:cNvSpPr txBox="1"/>
            <p:nvPr/>
          </p:nvSpPr>
          <p:spPr>
            <a:xfrm>
              <a:off x="326028" y="2801670"/>
              <a:ext cx="3289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B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A7B3E584-466A-4CD4-B062-CCAABF4A2AE4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969654" y="3652194"/>
              <a:ext cx="1147567" cy="324845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99156D54-C6D2-4FE4-AE55-2B01C676311A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206580" y="3652194"/>
              <a:ext cx="1147567" cy="318815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75DAF7BA-E357-4FC8-BF53-6A61EB2BB6D4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590800" y="3653911"/>
              <a:ext cx="1159753" cy="317098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A0B78F9F-DCEB-43BC-B4EF-23FC5EA9036C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1206580" y="4049282"/>
              <a:ext cx="1147567" cy="158839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C9AA22B8-2CD6-4514-8CAC-633FF63634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590800" y="4049282"/>
              <a:ext cx="1159753" cy="158839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1BCF42DC-BCCC-4BE8-9C0D-1A33161AF0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962400" y="4039298"/>
              <a:ext cx="1154821" cy="168823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5BBF63D-AEF1-4FD5-A795-55F7CD47DDA4}"/>
                </a:ext>
              </a:extLst>
            </p:cNvPr>
            <p:cNvSpPr txBox="1"/>
            <p:nvPr/>
          </p:nvSpPr>
          <p:spPr>
            <a:xfrm>
              <a:off x="1432127" y="2857950"/>
              <a:ext cx="9297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MiaPaCa2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E02E055-ED72-4474-9EF7-E5195E03DFAB}"/>
                </a:ext>
              </a:extLst>
            </p:cNvPr>
            <p:cNvSpPr txBox="1"/>
            <p:nvPr/>
          </p:nvSpPr>
          <p:spPr>
            <a:xfrm>
              <a:off x="2811932" y="2851190"/>
              <a:ext cx="6828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Panc-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8A034B0-1199-4314-9036-2D11F22A378A}"/>
                </a:ext>
              </a:extLst>
            </p:cNvPr>
            <p:cNvSpPr txBox="1"/>
            <p:nvPr/>
          </p:nvSpPr>
          <p:spPr>
            <a:xfrm>
              <a:off x="4248173" y="2847837"/>
              <a:ext cx="7056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Nor-P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1C02EF0-A68F-4968-9246-B373696D244F}"/>
                </a:ext>
              </a:extLst>
            </p:cNvPr>
            <p:cNvSpPr txBox="1"/>
            <p:nvPr/>
          </p:nvSpPr>
          <p:spPr>
            <a:xfrm rot="20036751">
              <a:off x="1147051" y="3296758"/>
              <a:ext cx="1000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cramble siRNA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EB17A24-0953-42B2-9480-969CC6A95649}"/>
                </a:ext>
              </a:extLst>
            </p:cNvPr>
            <p:cNvSpPr txBox="1"/>
            <p:nvPr/>
          </p:nvSpPr>
          <p:spPr>
            <a:xfrm rot="20079689">
              <a:off x="1849934" y="3336777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DPK1 siRNA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E174ABF-F8B2-4377-A2B0-7DBC61D007D7}"/>
                </a:ext>
              </a:extLst>
            </p:cNvPr>
            <p:cNvSpPr txBox="1"/>
            <p:nvPr/>
          </p:nvSpPr>
          <p:spPr>
            <a:xfrm rot="20175641">
              <a:off x="2603131" y="3298547"/>
              <a:ext cx="1000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cramble siRN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BB8EEEA-78F6-4C99-9272-A7B3B64B392F}"/>
                </a:ext>
              </a:extLst>
            </p:cNvPr>
            <p:cNvSpPr txBox="1"/>
            <p:nvPr/>
          </p:nvSpPr>
          <p:spPr>
            <a:xfrm rot="20126952">
              <a:off x="3313274" y="3332124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DPK1 siRNA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B3C3B7D-A8FB-40BE-93F2-C86D917D328C}"/>
                </a:ext>
              </a:extLst>
            </p:cNvPr>
            <p:cNvSpPr txBox="1"/>
            <p:nvPr/>
          </p:nvSpPr>
          <p:spPr>
            <a:xfrm rot="19993028">
              <a:off x="3986892" y="3291999"/>
              <a:ext cx="1000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cramble siRNA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0F5C6F5-ACD0-40EC-847A-4F72D8499E98}"/>
                </a:ext>
              </a:extLst>
            </p:cNvPr>
            <p:cNvSpPr txBox="1"/>
            <p:nvPr/>
          </p:nvSpPr>
          <p:spPr>
            <a:xfrm rot="19906356">
              <a:off x="4745907" y="3304072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PDPK1 siRNA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6EFAFFF-401A-4CD2-8C36-1BD2290711CF}"/>
                </a:ext>
              </a:extLst>
            </p:cNvPr>
            <p:cNvSpPr txBox="1"/>
            <p:nvPr/>
          </p:nvSpPr>
          <p:spPr>
            <a:xfrm>
              <a:off x="228600" y="3646320"/>
              <a:ext cx="968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Total-PDPK1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369DA34-2F37-4FD6-94C6-960ADB58F120}"/>
                </a:ext>
              </a:extLst>
            </p:cNvPr>
            <p:cNvSpPr txBox="1"/>
            <p:nvPr/>
          </p:nvSpPr>
          <p:spPr>
            <a:xfrm>
              <a:off x="358978" y="3990201"/>
              <a:ext cx="7078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/>
                <a:t>β</a:t>
              </a:r>
              <a:r>
                <a:rPr lang="en-US" sz="1200" b="1" dirty="0"/>
                <a:t>-ACTI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30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7</TotalTime>
  <Words>32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7</vt:lpstr>
      <vt:lpstr>Suppl. Fig. 1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Taylor Aiken</dc:creator>
  <cp:lastModifiedBy>Li, Dandan (NIH/NCI) [F]</cp:lastModifiedBy>
  <cp:revision>205</cp:revision>
  <cp:lastPrinted>2018-05-31T17:03:16Z</cp:lastPrinted>
  <dcterms:created xsi:type="dcterms:W3CDTF">2016-07-16T21:12:22Z</dcterms:created>
  <dcterms:modified xsi:type="dcterms:W3CDTF">2018-06-08T20:24:47Z</dcterms:modified>
</cp:coreProperties>
</file>